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0" r:id="rId2"/>
  </p:sldIdLst>
  <p:sldSz cx="9144000" cy="6858000" type="screen4x3"/>
  <p:notesSz cx="6735763" cy="98663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9E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84" autoAdjust="0"/>
    <p:restoredTop sz="94660"/>
  </p:normalViewPr>
  <p:slideViewPr>
    <p:cSldViewPr>
      <p:cViewPr varScale="1">
        <p:scale>
          <a:sx n="113" d="100"/>
          <a:sy n="113" d="100"/>
        </p:scale>
        <p:origin x="-1080" y="-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960E48-7B3D-4662-8F7C-27EBB4BE3E0F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52C720-C2DA-4A05-8D4D-D505C707C3C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8625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7462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3148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820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8930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4182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6611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4781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383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2421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0185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6675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77613-B7E4-4B83-95BF-E53182ABBE84}" type="datetimeFigureOut">
              <a:rPr lang="ko-KR" altLang="en-US" smtClean="0"/>
              <a:t>2019-05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0D0488-B4ED-4CC1-B8D1-317FF00BDBA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2912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0E4A3E07-ED88-4966-828D-2C088BDBFAB2}"/>
              </a:ext>
            </a:extLst>
          </p:cNvPr>
          <p:cNvSpPr txBox="1"/>
          <p:nvPr/>
        </p:nvSpPr>
        <p:spPr>
          <a:xfrm>
            <a:off x="2341820" y="154136"/>
            <a:ext cx="44625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00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en-US" altLang="ko-KR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Table. </a:t>
            </a:r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List of primers for </a:t>
            </a:r>
            <a:r>
              <a:rPr lang="en-US" altLang="ko-KR" sz="20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-PCR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xmlns="" id="{B699DB0C-D59A-42CF-B82E-2AEF625F95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2312337"/>
              </p:ext>
            </p:extLst>
          </p:nvPr>
        </p:nvGraphicFramePr>
        <p:xfrm>
          <a:off x="1512763" y="717888"/>
          <a:ext cx="6120681" cy="453651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169119">
                  <a:extLst>
                    <a:ext uri="{9D8B030D-6E8A-4147-A177-3AD203B41FA5}">
                      <a16:colId xmlns:a16="http://schemas.microsoft.com/office/drawing/2014/main" xmlns="" val="3641224591"/>
                    </a:ext>
                  </a:extLst>
                </a:gridCol>
                <a:gridCol w="1169119">
                  <a:extLst>
                    <a:ext uri="{9D8B030D-6E8A-4147-A177-3AD203B41FA5}">
                      <a16:colId xmlns:a16="http://schemas.microsoft.com/office/drawing/2014/main" xmlns="" val="1954350929"/>
                    </a:ext>
                  </a:extLst>
                </a:gridCol>
                <a:gridCol w="2558306">
                  <a:extLst>
                    <a:ext uri="{9D8B030D-6E8A-4147-A177-3AD203B41FA5}">
                      <a16:colId xmlns:a16="http://schemas.microsoft.com/office/drawing/2014/main" xmlns="" val="1712644121"/>
                    </a:ext>
                  </a:extLst>
                </a:gridCol>
                <a:gridCol w="1224137">
                  <a:extLst>
                    <a:ext uri="{9D8B030D-6E8A-4147-A177-3AD203B41FA5}">
                      <a16:colId xmlns:a16="http://schemas.microsoft.com/office/drawing/2014/main" xmlns="" val="3500818555"/>
                    </a:ext>
                  </a:extLst>
                </a:gridCol>
              </a:tblGrid>
              <a:tr h="46505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bol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s</a:t>
                      </a:r>
                      <a:endParaRPr lang="ko-KR" alt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/>
                        <a:t>Size of product</a:t>
                      </a:r>
                      <a:endParaRPr lang="ko-KR" altLang="en-US" sz="1000" b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83926376"/>
                  </a:ext>
                </a:extLst>
              </a:tr>
              <a:tr h="254466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DR27</a:t>
                      </a:r>
                      <a:endParaRPr lang="ko-KR" alt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GGATTTCCAGAGCCTCA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 </a:t>
                      </a:r>
                      <a:r>
                        <a:rPr lang="en-US" altLang="ko-KR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243672851"/>
                  </a:ext>
                </a:extLst>
              </a:tr>
              <a:tr h="25446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GAGGTCGGTAGGACACA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00391292"/>
                  </a:ext>
                </a:extLst>
              </a:tr>
              <a:tr h="254466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NAS</a:t>
                      </a:r>
                      <a:endParaRPr lang="ko-KR" alt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GTGCCTGACTTTGACTTC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3 </a:t>
                      </a:r>
                      <a:r>
                        <a:rPr lang="en-US" altLang="ko-KR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837006734"/>
                  </a:ext>
                </a:extLst>
              </a:tr>
              <a:tr h="25446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TGTCCACCTGGAACTTGG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90669850"/>
                  </a:ext>
                </a:extLst>
              </a:tr>
              <a:tr h="254466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K7</a:t>
                      </a:r>
                      <a:endParaRPr lang="ko-KR" alt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TACCAGACCCAAGTCCC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2 </a:t>
                      </a:r>
                      <a:r>
                        <a:rPr lang="en-US" altLang="ko-KR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305429522"/>
                  </a:ext>
                </a:extLst>
              </a:tr>
              <a:tr h="25446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GACGACGAGGATTGC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12060816"/>
                  </a:ext>
                </a:extLst>
              </a:tr>
              <a:tr h="254466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DN3</a:t>
                      </a:r>
                      <a:endParaRPr lang="ko-KR" alt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ACCTACAAGGACAAGGAGT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1 </a:t>
                      </a:r>
                      <a:r>
                        <a:rPr lang="en-US" altLang="ko-KR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2163228207"/>
                  </a:ext>
                </a:extLst>
              </a:tr>
              <a:tr h="25446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AGATTCCCTGGAAGTGG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00978779"/>
                  </a:ext>
                </a:extLst>
              </a:tr>
              <a:tr h="254466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MYA5</a:t>
                      </a:r>
                      <a:endParaRPr lang="ko-KR" alt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TTGACACATACTGTTACACCTG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5 </a:t>
                      </a:r>
                      <a:r>
                        <a:rPr lang="en-US" altLang="ko-KR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4082117894"/>
                  </a:ext>
                </a:extLst>
              </a:tr>
              <a:tr h="25446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CTTCTTCATCATTTCCTCATTCT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87496815"/>
                  </a:ext>
                </a:extLst>
              </a:tr>
              <a:tr h="254466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KG1</a:t>
                      </a:r>
                      <a:endParaRPr lang="ko-KR" alt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CTGGACCATTCTCAGG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 </a:t>
                      </a:r>
                      <a:r>
                        <a:rPr lang="en-US" altLang="ko-KR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220121302"/>
                  </a:ext>
                </a:extLst>
              </a:tr>
              <a:tr h="25446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CCTTTGTTCAGGATG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93137"/>
                  </a:ext>
                </a:extLst>
              </a:tr>
              <a:tr h="254466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F2L</a:t>
                      </a:r>
                      <a:endParaRPr lang="ko-KR" alt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TGAACCAGGACCAGC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 </a:t>
                      </a:r>
                      <a:r>
                        <a:rPr lang="en-US" altLang="ko-KR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7379713"/>
                  </a:ext>
                </a:extLst>
              </a:tr>
              <a:tr h="25446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TTGCCGATGTCTGTGAA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81822772"/>
                  </a:ext>
                </a:extLst>
              </a:tr>
              <a:tr h="254466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endParaRPr lang="ko-KR" altLang="en-US" sz="1000" b="1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CGTCAAGGCTGAGAAC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2 </a:t>
                      </a:r>
                      <a:r>
                        <a:rPr lang="en-US" altLang="ko-KR" sz="9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p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3017332573"/>
                  </a:ext>
                </a:extLst>
              </a:tr>
              <a:tr h="25446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GAGGCATTGCTGATGAT</a:t>
                      </a:r>
                      <a:endParaRPr lang="ko-KR" altLang="en-US" sz="9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25536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96918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58</TotalTime>
  <Words>69</Words>
  <Application>Microsoft Office PowerPoint</Application>
  <PresentationFormat>화면 슬라이드 쇼(4:3)</PresentationFormat>
  <Paragraphs>52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AEHOKFRI</dc:creator>
  <cp:lastModifiedBy>Ryzen_JAEHO</cp:lastModifiedBy>
  <cp:revision>424</cp:revision>
  <cp:lastPrinted>2018-01-29T12:39:48Z</cp:lastPrinted>
  <dcterms:created xsi:type="dcterms:W3CDTF">2016-12-05T06:47:22Z</dcterms:created>
  <dcterms:modified xsi:type="dcterms:W3CDTF">2019-05-27T01:24:03Z</dcterms:modified>
</cp:coreProperties>
</file>